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8" r:id="rId2"/>
  </p:sldIdLst>
  <p:sldSz cx="169164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32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z, Alexander" userId="302c93c3-6320-4d3c-a68d-a1fdc247d2f3" providerId="ADAL" clId="{C560CC54-4234-4442-B9E5-4C09CEC1DC15}"/>
    <pc:docChg chg="modSld">
      <pc:chgData name="Franz, Alexander" userId="302c93c3-6320-4d3c-a68d-a1fdc247d2f3" providerId="ADAL" clId="{C560CC54-4234-4442-B9E5-4C09CEC1DC15}" dt="2025-06-16T20:08:08.997" v="10" actId="20577"/>
      <pc:docMkLst>
        <pc:docMk/>
      </pc:docMkLst>
      <pc:sldChg chg="modSp mod">
        <pc:chgData name="Franz, Alexander" userId="302c93c3-6320-4d3c-a68d-a1fdc247d2f3" providerId="ADAL" clId="{C560CC54-4234-4442-B9E5-4C09CEC1DC15}" dt="2025-06-16T20:08:08.997" v="10" actId="20577"/>
        <pc:sldMkLst>
          <pc:docMk/>
          <pc:sldMk cId="840736208" sldId="268"/>
        </pc:sldMkLst>
        <pc:spChg chg="mod">
          <ac:chgData name="Franz, Alexander" userId="302c93c3-6320-4d3c-a68d-a1fdc247d2f3" providerId="ADAL" clId="{C560CC54-4234-4442-B9E5-4C09CEC1DC15}" dt="2025-06-16T20:08:08.997" v="10" actId="20577"/>
          <ac:spMkLst>
            <pc:docMk/>
            <pc:sldMk cId="840736208" sldId="268"/>
            <ac:spMk id="40" creationId="{C779BEDC-45E8-6F28-197B-5875717BA5EC}"/>
          </ac:spMkLst>
        </pc:spChg>
      </pc:sldChg>
    </pc:docChg>
  </pc:docChgLst>
  <pc:docChgLst>
    <pc:chgData name="Franz, Alexander" userId="302c93c3-6320-4d3c-a68d-a1fdc247d2f3" providerId="ADAL" clId="{96FA9373-4BB5-431C-B6A8-611B210DA615}"/>
    <pc:docChg chg="delSld">
      <pc:chgData name="Franz, Alexander" userId="302c93c3-6320-4d3c-a68d-a1fdc247d2f3" providerId="ADAL" clId="{96FA9373-4BB5-431C-B6A8-611B210DA615}" dt="2025-05-09T15:13:27.605" v="6" actId="47"/>
      <pc:docMkLst>
        <pc:docMk/>
      </pc:docMkLst>
      <pc:sldChg chg="del">
        <pc:chgData name="Franz, Alexander" userId="302c93c3-6320-4d3c-a68d-a1fdc247d2f3" providerId="ADAL" clId="{96FA9373-4BB5-431C-B6A8-611B210DA615}" dt="2025-05-09T15:13:24.065" v="0" actId="47"/>
        <pc:sldMkLst>
          <pc:docMk/>
          <pc:sldMk cId="3770325497" sldId="260"/>
        </pc:sldMkLst>
      </pc:sldChg>
      <pc:sldChg chg="del">
        <pc:chgData name="Franz, Alexander" userId="302c93c3-6320-4d3c-a68d-a1fdc247d2f3" providerId="ADAL" clId="{96FA9373-4BB5-431C-B6A8-611B210DA615}" dt="2025-05-09T15:13:24.529" v="1" actId="47"/>
        <pc:sldMkLst>
          <pc:docMk/>
          <pc:sldMk cId="3090315556" sldId="274"/>
        </pc:sldMkLst>
      </pc:sldChg>
      <pc:sldChg chg="del">
        <pc:chgData name="Franz, Alexander" userId="302c93c3-6320-4d3c-a68d-a1fdc247d2f3" providerId="ADAL" clId="{96FA9373-4BB5-431C-B6A8-611B210DA615}" dt="2025-05-09T15:13:25.131" v="2" actId="47"/>
        <pc:sldMkLst>
          <pc:docMk/>
          <pc:sldMk cId="1558593817" sldId="282"/>
        </pc:sldMkLst>
      </pc:sldChg>
      <pc:sldChg chg="del">
        <pc:chgData name="Franz, Alexander" userId="302c93c3-6320-4d3c-a68d-a1fdc247d2f3" providerId="ADAL" clId="{96FA9373-4BB5-431C-B6A8-611B210DA615}" dt="2025-05-09T15:13:27.605" v="6" actId="47"/>
        <pc:sldMkLst>
          <pc:docMk/>
          <pc:sldMk cId="738394285" sldId="283"/>
        </pc:sldMkLst>
      </pc:sldChg>
      <pc:sldChg chg="del">
        <pc:chgData name="Franz, Alexander" userId="302c93c3-6320-4d3c-a68d-a1fdc247d2f3" providerId="ADAL" clId="{96FA9373-4BB5-431C-B6A8-611B210DA615}" dt="2025-05-09T15:13:25.721" v="3" actId="47"/>
        <pc:sldMkLst>
          <pc:docMk/>
          <pc:sldMk cId="3154073227" sldId="284"/>
        </pc:sldMkLst>
      </pc:sldChg>
      <pc:sldChg chg="del">
        <pc:chgData name="Franz, Alexander" userId="302c93c3-6320-4d3c-a68d-a1fdc247d2f3" providerId="ADAL" clId="{96FA9373-4BB5-431C-B6A8-611B210DA615}" dt="2025-05-09T15:13:26.270" v="4" actId="47"/>
        <pc:sldMkLst>
          <pc:docMk/>
          <pc:sldMk cId="342682865" sldId="288"/>
        </pc:sldMkLst>
      </pc:sldChg>
      <pc:sldChg chg="del">
        <pc:chgData name="Franz, Alexander" userId="302c93c3-6320-4d3c-a68d-a1fdc247d2f3" providerId="ADAL" clId="{96FA9373-4BB5-431C-B6A8-611B210DA615}" dt="2025-05-09T15:13:26.811" v="5" actId="47"/>
        <pc:sldMkLst>
          <pc:docMk/>
          <pc:sldMk cId="569847685" sldId="289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Genotype fitting,</a:t>
            </a:r>
            <a:r>
              <a:rPr lang="en-US" baseline="0" dirty="0"/>
              <a:t> smoothing function, nanos-GD</a:t>
            </a:r>
            <a:endParaRPr lang="en-US" dirty="0"/>
          </a:p>
        </c:rich>
      </c:tx>
      <c:layout>
        <c:manualLayout>
          <c:xMode val="edge"/>
          <c:yMode val="edge"/>
          <c:x val="0.21362204724409448"/>
          <c:y val="5.93839858755112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549187252880944"/>
          <c:y val="0.1501673469769175"/>
          <c:w val="0.84787621236186683"/>
          <c:h val="0.71134477757758507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poly"/>
            <c:order val="2"/>
            <c:intercept val="0.2"/>
            <c:dispRSqr val="1"/>
            <c:dispEq val="1"/>
            <c:trendlineLbl>
              <c:layout>
                <c:manualLayout>
                  <c:x val="-8.8289588801399831E-3"/>
                  <c:y val="0.27174868766404198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genotype samples'!$AL$58:$AL$63</c:f>
              <c:numCache>
                <c:formatCode>0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genotype samples'!$AM$58:$AM$63</c:f>
              <c:numCache>
                <c:formatCode>0.00</c:formatCode>
                <c:ptCount val="6"/>
                <c:pt idx="0">
                  <c:v>0.39130434782608697</c:v>
                </c:pt>
                <c:pt idx="1">
                  <c:v>0.68888888888888888</c:v>
                </c:pt>
                <c:pt idx="2">
                  <c:v>0.76666666666666672</c:v>
                </c:pt>
                <c:pt idx="3">
                  <c:v>0.8666666666666667</c:v>
                </c:pt>
                <c:pt idx="4">
                  <c:v>0.83333333333333337</c:v>
                </c:pt>
                <c:pt idx="5">
                  <c:v>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B66-40C8-BE9D-8289566FA9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4332960"/>
        <c:axId val="544332600"/>
      </c:scatterChart>
      <c:valAx>
        <c:axId val="544332960"/>
        <c:scaling>
          <c:orientation val="minMax"/>
          <c:max val="6"/>
        </c:scaling>
        <c:delete val="0"/>
        <c:axPos val="b"/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332600"/>
        <c:crosses val="autoZero"/>
        <c:crossBetween val="midCat"/>
      </c:valAx>
      <c:valAx>
        <c:axId val="5443326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/>
                  <a:t>Homozygosit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3329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Genotype</a:t>
            </a:r>
            <a:r>
              <a:rPr lang="en-US" baseline="0" dirty="0"/>
              <a:t> fitting, smoothing function, </a:t>
            </a:r>
            <a:r>
              <a:rPr lang="en-US" baseline="0" dirty="0" err="1"/>
              <a:t>zpg</a:t>
            </a:r>
            <a:r>
              <a:rPr lang="en-US" baseline="0" dirty="0"/>
              <a:t>-GD</a:t>
            </a:r>
            <a:endParaRPr lang="en-US" dirty="0"/>
          </a:p>
        </c:rich>
      </c:tx>
      <c:layout>
        <c:manualLayout>
          <c:xMode val="edge"/>
          <c:yMode val="edge"/>
          <c:x val="0.19996308683838948"/>
          <c:y val="5.74252160906359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7583690605476614E-2"/>
          <c:y val="0.17171296296296298"/>
          <c:w val="0.86552754441379942"/>
          <c:h val="0.72088764946048411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poly"/>
            <c:order val="2"/>
            <c:intercept val="0.2"/>
            <c:dispRSqr val="1"/>
            <c:dispEq val="1"/>
            <c:trendlineLbl>
              <c:layout>
                <c:manualLayout>
                  <c:x val="-0.37246391076115487"/>
                  <c:y val="-3.5816564596092157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genotype samples'!$AL$71:$AL$76</c:f>
              <c:numCache>
                <c:formatCode>0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genotype samples'!$AM$71:$AM$76</c:f>
              <c:numCache>
                <c:formatCode>General</c:formatCode>
                <c:ptCount val="6"/>
                <c:pt idx="0">
                  <c:v>0.36349999999999999</c:v>
                </c:pt>
                <c:pt idx="1">
                  <c:v>0.45999999999999996</c:v>
                </c:pt>
                <c:pt idx="2">
                  <c:v>0.62</c:v>
                </c:pt>
                <c:pt idx="3">
                  <c:v>0.64999999999999991</c:v>
                </c:pt>
                <c:pt idx="4">
                  <c:v>0.6835</c:v>
                </c:pt>
                <c:pt idx="5">
                  <c:v>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A79-411C-8B4B-FD4837B6A3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2619536"/>
        <c:axId val="642611976"/>
      </c:scatterChart>
      <c:valAx>
        <c:axId val="642619536"/>
        <c:scaling>
          <c:orientation val="minMax"/>
          <c:max val="6"/>
        </c:scaling>
        <c:delete val="0"/>
        <c:axPos val="b"/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2611976"/>
        <c:crosses val="autoZero"/>
        <c:crossBetween val="midCat"/>
      </c:valAx>
      <c:valAx>
        <c:axId val="642611976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/>
                  <a:t>Homozygosit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26195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2EB3E9-7FC1-4091-982A-3ED580D49C5A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143000"/>
            <a:ext cx="2378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D2B3F1-9DE9-4B62-87EA-66A776D0C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605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1pPr>
    <a:lvl2pPr marL="563179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2pPr>
    <a:lvl3pPr marL="1126358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3pPr>
    <a:lvl4pPr marL="1689537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4pPr>
    <a:lvl5pPr marL="2252716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5pPr>
    <a:lvl6pPr marL="2815895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6pPr>
    <a:lvl7pPr marL="3379074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7pPr>
    <a:lvl8pPr marL="3942253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8pPr>
    <a:lvl9pPr marL="4505432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D2B3F1-9DE9-4B62-87EA-66A776D0C75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5072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8730" y="3591562"/>
            <a:ext cx="14378940" cy="7640320"/>
          </a:xfrm>
        </p:spPr>
        <p:txBody>
          <a:bodyPr anchor="b"/>
          <a:lstStyle>
            <a:lvl1pPr algn="ctr"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14550" y="11526522"/>
            <a:ext cx="12687300" cy="5298438"/>
          </a:xfrm>
        </p:spPr>
        <p:txBody>
          <a:bodyPr/>
          <a:lstStyle>
            <a:lvl1pPr marL="0" indent="0" algn="ctr">
              <a:buNone/>
              <a:defRPr sz="4440"/>
            </a:lvl1pPr>
            <a:lvl2pPr marL="845820" indent="0" algn="ctr">
              <a:buNone/>
              <a:defRPr sz="3700"/>
            </a:lvl2pPr>
            <a:lvl3pPr marL="1691640" indent="0" algn="ctr">
              <a:buNone/>
              <a:defRPr sz="3330"/>
            </a:lvl3pPr>
            <a:lvl4pPr marL="2537460" indent="0" algn="ctr">
              <a:buNone/>
              <a:defRPr sz="2960"/>
            </a:lvl4pPr>
            <a:lvl5pPr marL="3383280" indent="0" algn="ctr">
              <a:buNone/>
              <a:defRPr sz="2960"/>
            </a:lvl5pPr>
            <a:lvl6pPr marL="4229100" indent="0" algn="ctr">
              <a:buNone/>
              <a:defRPr sz="2960"/>
            </a:lvl6pPr>
            <a:lvl7pPr marL="5074920" indent="0" algn="ctr">
              <a:buNone/>
              <a:defRPr sz="2960"/>
            </a:lvl7pPr>
            <a:lvl8pPr marL="5920740" indent="0" algn="ctr">
              <a:buNone/>
              <a:defRPr sz="2960"/>
            </a:lvl8pPr>
            <a:lvl9pPr marL="6766560" indent="0" algn="ctr">
              <a:buNone/>
              <a:defRPr sz="2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46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26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105800" y="1168400"/>
            <a:ext cx="3647599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63004" y="1168400"/>
            <a:ext cx="10731341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74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658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93" y="5471167"/>
            <a:ext cx="14590395" cy="9128758"/>
          </a:xfrm>
        </p:spPr>
        <p:txBody>
          <a:bodyPr anchor="b"/>
          <a:lstStyle>
            <a:lvl1pPr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193" y="14686287"/>
            <a:ext cx="14590395" cy="4800598"/>
          </a:xfrm>
        </p:spPr>
        <p:txBody>
          <a:bodyPr/>
          <a:lstStyle>
            <a:lvl1pPr marL="0" indent="0">
              <a:buNone/>
              <a:defRPr sz="4440">
                <a:solidFill>
                  <a:schemeClr val="tx1">
                    <a:tint val="82000"/>
                  </a:schemeClr>
                </a:solidFill>
              </a:defRPr>
            </a:lvl1pPr>
            <a:lvl2pPr marL="845820" indent="0">
              <a:buNone/>
              <a:defRPr sz="3700">
                <a:solidFill>
                  <a:schemeClr val="tx1">
                    <a:tint val="82000"/>
                  </a:schemeClr>
                </a:solidFill>
              </a:defRPr>
            </a:lvl2pPr>
            <a:lvl3pPr marL="1691640" indent="0">
              <a:buNone/>
              <a:defRPr sz="3330">
                <a:solidFill>
                  <a:schemeClr val="tx1">
                    <a:tint val="82000"/>
                  </a:schemeClr>
                </a:solidFill>
              </a:defRPr>
            </a:lvl3pPr>
            <a:lvl4pPr marL="25374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4pPr>
            <a:lvl5pPr marL="338328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5pPr>
            <a:lvl6pPr marL="422910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6pPr>
            <a:lvl7pPr marL="507492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7pPr>
            <a:lvl8pPr marL="592074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8pPr>
            <a:lvl9pPr marL="67665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91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63003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63928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28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168405"/>
            <a:ext cx="14590395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5208" y="5379722"/>
            <a:ext cx="7156429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5208" y="8016240"/>
            <a:ext cx="715642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563929" y="5379722"/>
            <a:ext cx="7191673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563929" y="8016240"/>
            <a:ext cx="7191673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1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334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07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1673" y="3159765"/>
            <a:ext cx="8563928" cy="15595600"/>
          </a:xfrm>
        </p:spPr>
        <p:txBody>
          <a:bodyPr/>
          <a:lstStyle>
            <a:lvl1pPr>
              <a:defRPr sz="5920"/>
            </a:lvl1pPr>
            <a:lvl2pPr>
              <a:defRPr sz="5180"/>
            </a:lvl2pPr>
            <a:lvl3pPr>
              <a:defRPr sz="444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72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191673" y="3159765"/>
            <a:ext cx="8563928" cy="15595600"/>
          </a:xfrm>
        </p:spPr>
        <p:txBody>
          <a:bodyPr anchor="t"/>
          <a:lstStyle>
            <a:lvl1pPr marL="0" indent="0">
              <a:buNone/>
              <a:defRPr sz="5920"/>
            </a:lvl1pPr>
            <a:lvl2pPr marL="845820" indent="0">
              <a:buNone/>
              <a:defRPr sz="5180"/>
            </a:lvl2pPr>
            <a:lvl3pPr marL="1691640" indent="0">
              <a:buNone/>
              <a:defRPr sz="4440"/>
            </a:lvl3pPr>
            <a:lvl4pPr marL="2537460" indent="0">
              <a:buNone/>
              <a:defRPr sz="3700"/>
            </a:lvl4pPr>
            <a:lvl5pPr marL="3383280" indent="0">
              <a:buNone/>
              <a:defRPr sz="3700"/>
            </a:lvl5pPr>
            <a:lvl6pPr marL="4229100" indent="0">
              <a:buNone/>
              <a:defRPr sz="3700"/>
            </a:lvl6pPr>
            <a:lvl7pPr marL="5074920" indent="0">
              <a:buNone/>
              <a:defRPr sz="3700"/>
            </a:lvl7pPr>
            <a:lvl8pPr marL="5920740" indent="0">
              <a:buNone/>
              <a:defRPr sz="3700"/>
            </a:lvl8pPr>
            <a:lvl9pPr marL="6766560" indent="0">
              <a:buNone/>
              <a:defRPr sz="3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34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63003" y="1168405"/>
            <a:ext cx="14590395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3003" y="5842000"/>
            <a:ext cx="14590395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63003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03558" y="20340325"/>
            <a:ext cx="5709285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947208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59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91640" rtl="0" eaLnBrk="1" latinLnBrk="0" hangingPunct="1">
        <a:lnSpc>
          <a:spcPct val="90000"/>
        </a:lnSpc>
        <a:spcBef>
          <a:spcPct val="0"/>
        </a:spcBef>
        <a:buNone/>
        <a:defRPr sz="81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2910" indent="-422910" algn="l" defTabSz="1691640" rtl="0" eaLnBrk="1" latinLnBrk="0" hangingPunct="1">
        <a:lnSpc>
          <a:spcPct val="90000"/>
        </a:lnSpc>
        <a:spcBef>
          <a:spcPts val="1850"/>
        </a:spcBef>
        <a:buFont typeface="Arial" panose="020B0604020202020204" pitchFamily="34" charset="0"/>
        <a:buChar char="•"/>
        <a:defRPr sz="5180" kern="1200">
          <a:solidFill>
            <a:schemeClr val="tx1"/>
          </a:solidFill>
          <a:latin typeface="+mn-lt"/>
          <a:ea typeface="+mn-ea"/>
          <a:cs typeface="+mn-cs"/>
        </a:defRPr>
      </a:lvl1pPr>
      <a:lvl2pPr marL="12687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4440" kern="1200">
          <a:solidFill>
            <a:schemeClr val="tx1"/>
          </a:solidFill>
          <a:latin typeface="+mn-lt"/>
          <a:ea typeface="+mn-ea"/>
          <a:cs typeface="+mn-cs"/>
        </a:defRPr>
      </a:lvl2pPr>
      <a:lvl3pPr marL="21145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9603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80619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65201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4978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63436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71894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1pPr>
      <a:lvl2pPr marL="8458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2pPr>
      <a:lvl3pPr marL="16916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3pPr>
      <a:lvl4pPr marL="25374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38328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22910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0749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59207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67665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C779BEDC-45E8-6F28-197B-5875717BA5EC}"/>
              </a:ext>
            </a:extLst>
          </p:cNvPr>
          <p:cNvSpPr txBox="1"/>
          <p:nvPr/>
        </p:nvSpPr>
        <p:spPr>
          <a:xfrm>
            <a:off x="1248594" y="5429506"/>
            <a:ext cx="1478281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0">
              <a:spcBef>
                <a:spcPts val="0"/>
              </a:spcBef>
              <a:spcAft>
                <a:spcPts val="0"/>
              </a:spcAft>
            </a:pPr>
            <a:r>
              <a:rPr lang="en-US" sz="2400" b="1" dirty="0"/>
              <a:t>S4 Fig. Genotype smoothing function applied to homozygosity. </a:t>
            </a:r>
            <a:r>
              <a:rPr lang="en-US" sz="2400" dirty="0" err="1"/>
              <a:t>Homozygosity</a:t>
            </a:r>
            <a:r>
              <a:rPr lang="en-US" sz="2400" dirty="0"/>
              <a:t> of the GD carriers was averaged for two generations at a time for mosquitoes carrying the </a:t>
            </a:r>
            <a:r>
              <a:rPr lang="en-US" sz="2400" i="1" dirty="0"/>
              <a:t>nanos</a:t>
            </a:r>
            <a:r>
              <a:rPr lang="en-US" sz="2400" dirty="0"/>
              <a:t>-GD (left panel) or </a:t>
            </a:r>
            <a:r>
              <a:rPr lang="en-US" sz="2400" i="1" dirty="0"/>
              <a:t>zpg</a:t>
            </a:r>
            <a:r>
              <a:rPr lang="en-US" sz="2400" dirty="0"/>
              <a:t>-GD (right panel) in Experiment A to decrease noise from low sampling numbers (≤30) at each individual generation. A second order polynomial function was fit to the genotype data obtained from allele-specific PCR.  The function was applied along with cage trial counts to estimate the GD allele frequencies shown in Fig. 1E.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EF50A9A8-DB4A-BB11-A428-C7CB1E63545E}"/>
              </a:ext>
            </a:extLst>
          </p:cNvPr>
          <p:cNvGrpSpPr/>
          <p:nvPr/>
        </p:nvGrpSpPr>
        <p:grpSpPr>
          <a:xfrm>
            <a:off x="1124207" y="930442"/>
            <a:ext cx="7055601" cy="4185924"/>
            <a:chOff x="1625600" y="1658677"/>
            <a:chExt cx="6457959" cy="3393521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08A95296-DC7E-A48A-1F99-E0328FD0C01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86329290"/>
                </p:ext>
              </p:extLst>
            </p:nvPr>
          </p:nvGraphicFramePr>
          <p:xfrm>
            <a:off x="1625600" y="1658677"/>
            <a:ext cx="5918200" cy="33173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5AE8D95-CFC9-6E65-3604-D718FEAB30DF}"/>
                </a:ext>
              </a:extLst>
            </p:cNvPr>
            <p:cNvSpPr txBox="1"/>
            <p:nvPr/>
          </p:nvSpPr>
          <p:spPr>
            <a:xfrm>
              <a:off x="2755255" y="4713644"/>
              <a:ext cx="7618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G1/G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C10BD07-4A3F-2655-02CA-1952A21030D0}"/>
                </a:ext>
              </a:extLst>
            </p:cNvPr>
            <p:cNvSpPr txBox="1"/>
            <p:nvPr/>
          </p:nvSpPr>
          <p:spPr>
            <a:xfrm rot="10800000" flipH="1" flipV="1">
              <a:off x="3556238" y="4713642"/>
              <a:ext cx="761875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3/G4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2C192D5-B4E6-8FCB-06B7-322F4DD61768}"/>
                </a:ext>
              </a:extLst>
            </p:cNvPr>
            <p:cNvSpPr txBox="1"/>
            <p:nvPr/>
          </p:nvSpPr>
          <p:spPr>
            <a:xfrm rot="10800000" flipH="1" flipV="1">
              <a:off x="4409266" y="4713642"/>
              <a:ext cx="761875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5/G6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60418AF-2368-D9FC-B1CF-D68518080DB9}"/>
                </a:ext>
              </a:extLst>
            </p:cNvPr>
            <p:cNvSpPr txBox="1"/>
            <p:nvPr/>
          </p:nvSpPr>
          <p:spPr>
            <a:xfrm rot="10800000" flipH="1" flipV="1">
              <a:off x="5265576" y="4713643"/>
              <a:ext cx="761875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7/G8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B42474B-5984-842A-2DE0-EBE36A1FD511}"/>
                </a:ext>
              </a:extLst>
            </p:cNvPr>
            <p:cNvSpPr txBox="1"/>
            <p:nvPr/>
          </p:nvSpPr>
          <p:spPr>
            <a:xfrm rot="10800000" flipH="1" flipV="1">
              <a:off x="6027451" y="4713644"/>
              <a:ext cx="9706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9/G1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BCF1F3E-8331-BDAF-E20A-99329FA56A8B}"/>
                </a:ext>
              </a:extLst>
            </p:cNvPr>
            <p:cNvSpPr txBox="1"/>
            <p:nvPr/>
          </p:nvSpPr>
          <p:spPr>
            <a:xfrm rot="10800000" flipH="1" flipV="1">
              <a:off x="6829524" y="4713642"/>
              <a:ext cx="12540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11/G12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34BED49D-1C49-A613-2490-4D9AFA8904A8}"/>
              </a:ext>
            </a:extLst>
          </p:cNvPr>
          <p:cNvGrpSpPr/>
          <p:nvPr/>
        </p:nvGrpSpPr>
        <p:grpSpPr>
          <a:xfrm>
            <a:off x="8406059" y="753979"/>
            <a:ext cx="7379367" cy="4367095"/>
            <a:chOff x="9292245" y="1565561"/>
            <a:chExt cx="6283536" cy="3491345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2150FD8A-28E6-7F6A-F0F8-9DF00211384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45599909"/>
                </p:ext>
              </p:extLst>
            </p:nvPr>
          </p:nvGraphicFramePr>
          <p:xfrm>
            <a:off x="9292245" y="1565561"/>
            <a:ext cx="5656519" cy="33173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FB17EA8-F259-DC58-2ED2-A4F4D76865F4}"/>
                </a:ext>
              </a:extLst>
            </p:cNvPr>
            <p:cNvSpPr txBox="1"/>
            <p:nvPr/>
          </p:nvSpPr>
          <p:spPr>
            <a:xfrm>
              <a:off x="10239918" y="4713644"/>
              <a:ext cx="7618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G1/G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40FD1DA-FF44-93B5-98D0-F315124EB1D4}"/>
                </a:ext>
              </a:extLst>
            </p:cNvPr>
            <p:cNvSpPr txBox="1"/>
            <p:nvPr/>
          </p:nvSpPr>
          <p:spPr>
            <a:xfrm rot="10800000" flipH="1" flipV="1">
              <a:off x="11107816" y="4715796"/>
              <a:ext cx="761875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3/G4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8C00198-7622-D3CC-3D09-5E23EC548F00}"/>
                </a:ext>
              </a:extLst>
            </p:cNvPr>
            <p:cNvSpPr txBox="1"/>
            <p:nvPr/>
          </p:nvSpPr>
          <p:spPr>
            <a:xfrm rot="10800000" flipH="1" flipV="1">
              <a:off x="11959716" y="4718351"/>
              <a:ext cx="761875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5/G6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7EC615F-095A-07CF-15DA-3D028B4C7063}"/>
                </a:ext>
              </a:extLst>
            </p:cNvPr>
            <p:cNvSpPr txBox="1"/>
            <p:nvPr/>
          </p:nvSpPr>
          <p:spPr>
            <a:xfrm rot="10800000" flipH="1" flipV="1">
              <a:off x="12777214" y="4713642"/>
              <a:ext cx="761875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7/G8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47FB2AC-C591-A3B3-16FA-5052F33DEEB4}"/>
                </a:ext>
              </a:extLst>
            </p:cNvPr>
            <p:cNvSpPr txBox="1"/>
            <p:nvPr/>
          </p:nvSpPr>
          <p:spPr>
            <a:xfrm rot="10800000" flipH="1" flipV="1">
              <a:off x="13545759" y="4713642"/>
              <a:ext cx="9706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9/G1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C859D86-2766-E5C6-7F05-16598F61FDA8}"/>
                </a:ext>
              </a:extLst>
            </p:cNvPr>
            <p:cNvSpPr txBox="1"/>
            <p:nvPr/>
          </p:nvSpPr>
          <p:spPr>
            <a:xfrm rot="10800000" flipH="1" flipV="1">
              <a:off x="14321746" y="4713642"/>
              <a:ext cx="12540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G11/G1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40736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62</TotalTime>
  <Words>147</Words>
  <Application>Microsoft Office PowerPoint</Application>
  <PresentationFormat>Custom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ch Speth</dc:creator>
  <cp:lastModifiedBy>Franz, Alexander</cp:lastModifiedBy>
  <cp:revision>432</cp:revision>
  <dcterms:created xsi:type="dcterms:W3CDTF">2024-06-26T16:03:17Z</dcterms:created>
  <dcterms:modified xsi:type="dcterms:W3CDTF">2025-06-16T20:08:14Z</dcterms:modified>
</cp:coreProperties>
</file>